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29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9/10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9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20978" y="5595306"/>
            <a:ext cx="80283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Franks and Pomares-Millan (2020) Diabetologia DOI 10.1007/s00125-020-05246-w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78651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Omics studies workflow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F825CD7-774B-46C1-A3F5-C59C5EF92D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172" y="1294916"/>
            <a:ext cx="8712968" cy="39342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44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36</cp:revision>
  <dcterms:created xsi:type="dcterms:W3CDTF">2016-06-15T12:53:43Z</dcterms:created>
  <dcterms:modified xsi:type="dcterms:W3CDTF">2020-10-19T13:01:23Z</dcterms:modified>
</cp:coreProperties>
</file>